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2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34" y="-84"/>
      </p:cViewPr>
      <p:guideLst>
        <p:guide orient="horz" pos="23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99:$F$101</c:f>
                <c:numCache>
                  <c:formatCode>General</c:formatCode>
                  <c:ptCount val="3"/>
                  <c:pt idx="0">
                    <c:v>4.2770706486254548</c:v>
                  </c:pt>
                  <c:pt idx="1">
                    <c:v>24.434953334198234</c:v>
                  </c:pt>
                  <c:pt idx="2">
                    <c:v>6.39800316070917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99:$D$101</c:f>
              <c:strCache>
                <c:ptCount val="3"/>
                <c:pt idx="0">
                  <c:v>Veh</c:v>
                </c:pt>
                <c:pt idx="1">
                  <c:v>Act</c:v>
                </c:pt>
                <c:pt idx="2">
                  <c:v>Act+FST</c:v>
                </c:pt>
              </c:strCache>
            </c:strRef>
          </c:cat>
          <c:val>
            <c:numRef>
              <c:f>Sheet1!$E$99:$E$101</c:f>
              <c:numCache>
                <c:formatCode>General</c:formatCode>
                <c:ptCount val="3"/>
                <c:pt idx="0">
                  <c:v>22.5</c:v>
                </c:pt>
                <c:pt idx="1">
                  <c:v>96.483333333333334</c:v>
                </c:pt>
                <c:pt idx="2">
                  <c:v>24.2666666666666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81-4339-A931-B54DCC273B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757760"/>
        <c:axId val="68759552"/>
      </c:barChart>
      <c:catAx>
        <c:axId val="68757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759552"/>
        <c:crosses val="autoZero"/>
        <c:auto val="1"/>
        <c:lblAlgn val="ctr"/>
        <c:lblOffset val="100"/>
        <c:noMultiLvlLbl val="0"/>
      </c:catAx>
      <c:valAx>
        <c:axId val="687595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8757760"/>
        <c:crosses val="autoZero"/>
        <c:crossBetween val="between"/>
      </c:valAx>
      <c:spPr>
        <a:noFill/>
        <a:ln w="15875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C$29:$C$3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806124661324315</c:v>
                  </c:pt>
                  <c:pt idx="2">
                    <c:v>4.84462579681527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29:$A$31</c:f>
              <c:strCache>
                <c:ptCount val="3"/>
                <c:pt idx="0">
                  <c:v>Veh</c:v>
                </c:pt>
                <c:pt idx="1">
                  <c:v>Act </c:v>
                </c:pt>
                <c:pt idx="2">
                  <c:v>Act+FST</c:v>
                </c:pt>
              </c:strCache>
            </c:strRef>
          </c:cat>
          <c:val>
            <c:numRef>
              <c:f>Sheet1!$B$29:$B$31</c:f>
              <c:numCache>
                <c:formatCode>General</c:formatCode>
                <c:ptCount val="3"/>
                <c:pt idx="0">
                  <c:v>1</c:v>
                </c:pt>
                <c:pt idx="1">
                  <c:v>1.132025172152648</c:v>
                </c:pt>
                <c:pt idx="2">
                  <c:v>1.05674736410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82F-471A-89BC-4394A38A37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648960"/>
        <c:axId val="68650496"/>
      </c:barChart>
      <c:catAx>
        <c:axId val="686489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68650496"/>
        <c:crosses val="autoZero"/>
        <c:auto val="1"/>
        <c:lblAlgn val="ctr"/>
        <c:lblOffset val="100"/>
        <c:noMultiLvlLbl val="0"/>
      </c:catAx>
      <c:valAx>
        <c:axId val="6865049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68648960"/>
        <c:crosses val="autoZero"/>
        <c:crossBetween val="between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C$69:$C$71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7856919968257213E-2</c:v>
                  </c:pt>
                  <c:pt idx="2">
                    <c:v>0.10532985025730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69:$A$71</c:f>
              <c:strCache>
                <c:ptCount val="3"/>
                <c:pt idx="0">
                  <c:v>Veh</c:v>
                </c:pt>
                <c:pt idx="1">
                  <c:v>Act  </c:v>
                </c:pt>
                <c:pt idx="2">
                  <c:v>Act+FST</c:v>
                </c:pt>
              </c:strCache>
            </c:strRef>
          </c:cat>
          <c:val>
            <c:numRef>
              <c:f>Sheet1!$B$69:$B$71</c:f>
              <c:numCache>
                <c:formatCode>General</c:formatCode>
                <c:ptCount val="3"/>
                <c:pt idx="0">
                  <c:v>1</c:v>
                </c:pt>
                <c:pt idx="1">
                  <c:v>0.95029929489367582</c:v>
                </c:pt>
                <c:pt idx="2">
                  <c:v>1.04621296998740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C6F-4D31-BDF2-FED9A43D54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666880"/>
        <c:axId val="68668416"/>
      </c:barChart>
      <c:catAx>
        <c:axId val="6866688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68668416"/>
        <c:crosses val="autoZero"/>
        <c:auto val="1"/>
        <c:lblAlgn val="ctr"/>
        <c:lblOffset val="100"/>
        <c:noMultiLvlLbl val="0"/>
      </c:catAx>
      <c:valAx>
        <c:axId val="6866841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68666880"/>
        <c:crosses val="autoZero"/>
        <c:crossBetween val="between"/>
      </c:valAx>
      <c:spPr>
        <a:ln w="15875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9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4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054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81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62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30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4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4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16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65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/>
          <p:cNvSpPr txBox="1"/>
          <p:nvPr/>
        </p:nvSpPr>
        <p:spPr>
          <a:xfrm rot="16200000">
            <a:off x="2015526" y="5425051"/>
            <a:ext cx="1133644" cy="2145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94" dirty="0" smtClean="0">
                <a:latin typeface="Arial" panose="020B0604020202020204" pitchFamily="34" charset="0"/>
                <a:cs typeface="Arial" panose="020B0604020202020204" pitchFamily="34" charset="0"/>
              </a:rPr>
              <a:t># Invaded Cells/Field</a:t>
            </a:r>
            <a:endParaRPr lang="en-US" sz="79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3570572"/>
              </p:ext>
            </p:extLst>
          </p:nvPr>
        </p:nvGraphicFramePr>
        <p:xfrm>
          <a:off x="2588742" y="4924401"/>
          <a:ext cx="1828800" cy="13670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143895" y="700999"/>
            <a:ext cx="3276586" cy="33094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588" dirty="0">
                <a:latin typeface="Arial" panose="020B0604020202020204" pitchFamily="34" charset="0"/>
                <a:cs typeface="Arial" panose="020B0604020202020204" pitchFamily="34" charset="0"/>
              </a:rPr>
              <a:t>Seachrist, Darcie et al</a:t>
            </a:r>
            <a:r>
              <a:rPr lang="en-US" sz="1588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588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588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endParaRPr lang="en-US" sz="15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84405" y="1832580"/>
            <a:ext cx="286986" cy="290359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184405" y="4854939"/>
            <a:ext cx="286986" cy="290359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324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5804112"/>
              </p:ext>
            </p:extLst>
          </p:nvPr>
        </p:nvGraphicFramePr>
        <p:xfrm>
          <a:off x="2588742" y="3504290"/>
          <a:ext cx="1828801" cy="13691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0" name="TextBox 29"/>
          <p:cNvSpPr txBox="1"/>
          <p:nvPr/>
        </p:nvSpPr>
        <p:spPr>
          <a:xfrm rot="16200000">
            <a:off x="2012788" y="4017575"/>
            <a:ext cx="1133372" cy="20879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794" dirty="0">
                <a:latin typeface="Arial" panose="020B0604020202020204" pitchFamily="34" charset="0"/>
                <a:cs typeface="Arial" panose="020B0604020202020204" pitchFamily="34" charset="0"/>
              </a:rPr>
              <a:t>Relative Cell Number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350413" y="3411465"/>
            <a:ext cx="395991" cy="263109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147" dirty="0"/>
              <a:t>4T1</a:t>
            </a:r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5547373"/>
              </p:ext>
            </p:extLst>
          </p:nvPr>
        </p:nvGraphicFramePr>
        <p:xfrm>
          <a:off x="2591729" y="2017667"/>
          <a:ext cx="1828800" cy="13691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3" name="TextBox 32"/>
          <p:cNvSpPr txBox="1"/>
          <p:nvPr/>
        </p:nvSpPr>
        <p:spPr>
          <a:xfrm rot="16200000">
            <a:off x="2009800" y="2530951"/>
            <a:ext cx="1133372" cy="20879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794" dirty="0">
                <a:latin typeface="Arial" panose="020B0604020202020204" pitchFamily="34" charset="0"/>
                <a:cs typeface="Arial" panose="020B0604020202020204" pitchFamily="34" charset="0"/>
              </a:rPr>
              <a:t>Relative Cell Number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208547" y="1924840"/>
            <a:ext cx="679722" cy="263109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147" dirty="0"/>
              <a:t>MCF10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926333" y="5600933"/>
            <a:ext cx="258404" cy="2688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7" dirty="0"/>
              <a:t>†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474473" y="5005809"/>
            <a:ext cx="258404" cy="2688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7" dirty="0"/>
              <a:t>*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221371" y="4848756"/>
            <a:ext cx="654074" cy="263109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147" dirty="0" smtClean="0"/>
              <a:t>10ANeu</a:t>
            </a:r>
            <a:endParaRPr lang="en-US" sz="1147" dirty="0"/>
          </a:p>
        </p:txBody>
      </p:sp>
    </p:spTree>
    <p:extLst>
      <p:ext uri="{BB962C8B-B14F-4D97-AF65-F5344CB8AC3E}">
        <p14:creationId xmlns:p14="http://schemas.microsoft.com/office/powerpoint/2010/main" val="21915606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4</TotalTime>
  <Words>24</Words>
  <Application>Microsoft Office PowerPoint</Application>
  <PresentationFormat>Letter Paper (8.5x11 in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WRU S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ds8@case.edu</dc:creator>
  <cp:lastModifiedBy>Balindan, Danica Joy</cp:lastModifiedBy>
  <cp:revision>36</cp:revision>
  <dcterms:created xsi:type="dcterms:W3CDTF">2016-12-05T21:51:29Z</dcterms:created>
  <dcterms:modified xsi:type="dcterms:W3CDTF">2017-05-29T04:54:12Z</dcterms:modified>
</cp:coreProperties>
</file>